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67" y="9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57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516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428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257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147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69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563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277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899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13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256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CA221D-ADF8-4A1D-B497-E09AC35F276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9D089-DCC8-43AE-B5D5-2DCCACF2D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053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840" y="418012"/>
            <a:ext cx="9562011" cy="5233852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544287" y="5660575"/>
            <a:ext cx="114953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en-US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orrelation between β-</a:t>
            </a:r>
            <a:r>
              <a:rPr lang="en-US" altLang="en-US" u="sng" dirty="0" err="1">
                <a:solidFill>
                  <a:srgbClr val="008080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lang="en-US" altLang="en-US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lang="en-US" altLang="en-US" baseline="-30000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lang="en-US" altLang="en-US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lang="en-US" altLang="en-US" u="sng" dirty="0">
                <a:solidFill>
                  <a:srgbClr val="008080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lang="en-US" altLang="en-US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lang="en-US" altLang="en-US" baseline="-30000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lang="en-US" altLang="en-US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­) for reversed chloroquinolines against sensitive strain D6. A compound which had strong </a:t>
            </a:r>
            <a:r>
              <a:rPr lang="en-US" altLang="en-US" u="sng" dirty="0">
                <a:solidFill>
                  <a:srgbClr val="008080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lang="en-US" altLang="en-US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lang="en-US" altLang="en-US" baseline="-30000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lang="en-US" altLang="en-US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= 2 </a:t>
            </a:r>
            <a:r>
              <a:rPr lang="en-US" altLang="en-US" dirty="0" err="1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nM</a:t>
            </a:r>
            <a:r>
              <a:rPr lang="en-US" altLang="en-US" dirty="0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 was removed from the analysis due to its insoluble form in anti-</a:t>
            </a:r>
            <a:r>
              <a:rPr lang="en-US" altLang="en-US" u="sng" dirty="0" err="1">
                <a:solidFill>
                  <a:srgbClr val="008080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ozoin</a:t>
            </a:r>
            <a:r>
              <a:rPr lang="en-US" altLang="en-US">
                <a:solidFill>
                  <a:srgbClr val="0D0D0D"/>
                </a:solidFill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test.</a:t>
            </a:r>
            <a:r>
              <a:rPr lang="en-US" altLang="en-US" sz="1050"/>
              <a:t> </a:t>
            </a:r>
            <a:endParaRPr lang="en-US" altLang="en-US" sz="2800">
              <a:latin typeface="Arial" panose="020B0604020202020204" pitchFamily="34" charset="0"/>
            </a:endParaRPr>
          </a:p>
          <a:p>
            <a:r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8486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5:54:43Z</dcterms:created>
  <dcterms:modified xsi:type="dcterms:W3CDTF">2020-08-04T16:29:27Z</dcterms:modified>
</cp:coreProperties>
</file>